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800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3973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6033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2011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7476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26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14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6667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561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3168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8768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6356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C5DF1-9C71-374F-90F7-A82AC5B8EF14}" type="datetimeFigureOut">
              <a:rPr lang="es-ES" smtClean="0"/>
              <a:t>29/7/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21C89-F7E5-7D49-B6C4-7B97CF5D59CE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3479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5.png"/><Relationship Id="rId20" Type="http://schemas.openxmlformats.org/officeDocument/2006/relationships/image" Target="../media/image11.png"/><Relationship Id="rId21" Type="http://schemas.microsoft.com/office/2007/relationships/hdphoto" Target="../media/hdphoto9.wdp"/><Relationship Id="rId10" Type="http://schemas.openxmlformats.org/officeDocument/2006/relationships/image" Target="../media/image6.png"/><Relationship Id="rId11" Type="http://schemas.microsoft.com/office/2007/relationships/hdphoto" Target="../media/hdphoto4.wdp"/><Relationship Id="rId12" Type="http://schemas.openxmlformats.org/officeDocument/2006/relationships/image" Target="../media/image7.png"/><Relationship Id="rId13" Type="http://schemas.microsoft.com/office/2007/relationships/hdphoto" Target="../media/hdphoto5.wdp"/><Relationship Id="rId14" Type="http://schemas.openxmlformats.org/officeDocument/2006/relationships/image" Target="../media/image8.png"/><Relationship Id="rId15" Type="http://schemas.microsoft.com/office/2007/relationships/hdphoto" Target="../media/hdphoto6.wdp"/><Relationship Id="rId16" Type="http://schemas.openxmlformats.org/officeDocument/2006/relationships/image" Target="../media/image9.png"/><Relationship Id="rId17" Type="http://schemas.microsoft.com/office/2007/relationships/hdphoto" Target="../media/hdphoto7.wdp"/><Relationship Id="rId18" Type="http://schemas.openxmlformats.org/officeDocument/2006/relationships/image" Target="../media/image10.png"/><Relationship Id="rId19" Type="http://schemas.microsoft.com/office/2007/relationships/hdphoto" Target="../media/hdphoto8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png"/><Relationship Id="rId4" Type="http://schemas.microsoft.com/office/2007/relationships/hdphoto" Target="../media/hdphoto1.wdp"/><Relationship Id="rId5" Type="http://schemas.openxmlformats.org/officeDocument/2006/relationships/image" Target="../media/image3.png"/><Relationship Id="rId6" Type="http://schemas.microsoft.com/office/2007/relationships/hdphoto" Target="../media/hdphoto2.wdp"/><Relationship Id="rId7" Type="http://schemas.openxmlformats.org/officeDocument/2006/relationships/image" Target="../media/image4.png"/><Relationship Id="rId8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Agrupar 16"/>
          <p:cNvGrpSpPr/>
          <p:nvPr/>
        </p:nvGrpSpPr>
        <p:grpSpPr>
          <a:xfrm>
            <a:off x="177438" y="8887"/>
            <a:ext cx="8686676" cy="5951725"/>
            <a:chOff x="177438" y="124608"/>
            <a:chExt cx="8686676" cy="6468935"/>
          </a:xfrm>
        </p:grpSpPr>
        <p:grpSp>
          <p:nvGrpSpPr>
            <p:cNvPr id="57" name="Agrupar 56"/>
            <p:cNvGrpSpPr/>
            <p:nvPr/>
          </p:nvGrpSpPr>
          <p:grpSpPr>
            <a:xfrm>
              <a:off x="189398" y="267357"/>
              <a:ext cx="6105296" cy="6326186"/>
              <a:chOff x="189398" y="267357"/>
              <a:chExt cx="6105296" cy="6326186"/>
            </a:xfrm>
          </p:grpSpPr>
          <p:pic>
            <p:nvPicPr>
              <p:cNvPr id="4" name="Imagen 3" descr="magustree.pdf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398" y="267357"/>
                <a:ext cx="6105296" cy="6211886"/>
              </a:xfrm>
              <a:prstGeom prst="rect">
                <a:avLst/>
              </a:prstGeom>
            </p:spPr>
          </p:pic>
          <p:cxnSp>
            <p:nvCxnSpPr>
              <p:cNvPr id="54" name="Conector recto 53"/>
              <p:cNvCxnSpPr/>
              <p:nvPr/>
            </p:nvCxnSpPr>
            <p:spPr>
              <a:xfrm>
                <a:off x="685641" y="6593543"/>
                <a:ext cx="863600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Rectángulo 55"/>
              <p:cNvSpPr/>
              <p:nvPr/>
            </p:nvSpPr>
            <p:spPr>
              <a:xfrm>
                <a:off x="2781300" y="6282267"/>
                <a:ext cx="918633" cy="13531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sp>
          <p:nvSpPr>
            <p:cNvPr id="5" name="CuadroTexto 4"/>
            <p:cNvSpPr txBox="1"/>
            <p:nvPr/>
          </p:nvSpPr>
          <p:spPr>
            <a:xfrm>
              <a:off x="5255707" y="4869006"/>
              <a:ext cx="187455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Cylinder gloriamari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6" name="CuadroTexto 5"/>
            <p:cNvSpPr txBox="1"/>
            <p:nvPr/>
          </p:nvSpPr>
          <p:spPr>
            <a:xfrm>
              <a:off x="6213805" y="4089797"/>
              <a:ext cx="22088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Gastridium geographu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5739569" y="5323693"/>
              <a:ext cx="16975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Cylinder textile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5410752" y="2911661"/>
              <a:ext cx="19595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Pionoconus consor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3780287" y="6083197"/>
              <a:ext cx="19258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Chelyconus ermineu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6078438" y="5668159"/>
              <a:ext cx="1913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Eugeniconus nobili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6200468" y="4475562"/>
              <a:ext cx="16608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Gastridium tulipa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5199619" y="3308558"/>
              <a:ext cx="1869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Pionoconus striatu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3897616" y="3705455"/>
              <a:ext cx="180853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smtClean="0">
                  <a:latin typeface="Times New Roman"/>
                  <a:cs typeface="Times New Roman"/>
                </a:rPr>
                <a:t>Fulgiconus goudeyi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6715783" y="1290049"/>
              <a:ext cx="19595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i="1" dirty="0" err="1" smtClean="0">
                  <a:latin typeface="Times New Roman"/>
                  <a:cs typeface="Times New Roman"/>
                </a:rPr>
                <a:t>Pionoconus</a:t>
              </a:r>
              <a:r>
                <a:rPr lang="es-ES" sz="1400" i="1" dirty="0" smtClean="0">
                  <a:latin typeface="Times New Roman"/>
                  <a:cs typeface="Times New Roman"/>
                </a:rPr>
                <a:t> </a:t>
              </a:r>
              <a:r>
                <a:rPr lang="es-ES" sz="1400" i="1" dirty="0" err="1" smtClean="0">
                  <a:latin typeface="Times New Roman"/>
                  <a:cs typeface="Times New Roman"/>
                </a:rPr>
                <a:t>magus</a:t>
              </a:r>
              <a:endParaRPr lang="es-ES" sz="1400" i="1" dirty="0">
                <a:latin typeface="Times New Roman"/>
                <a:cs typeface="Times New Roman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5466457" y="124608"/>
              <a:ext cx="9227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KJ550365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5413831" y="504735"/>
              <a:ext cx="11622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SRX5015024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5356190" y="2482708"/>
              <a:ext cx="9227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KJ549945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5466457" y="2119231"/>
              <a:ext cx="9227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KJ550366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5413831" y="1734273"/>
              <a:ext cx="8863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FJ868118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5410752" y="911982"/>
              <a:ext cx="7132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OK206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5365157" y="1316459"/>
              <a:ext cx="7132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>
                  <a:latin typeface="Times New Roman"/>
                  <a:cs typeface="Times New Roman"/>
                </a:rPr>
                <a:t>OK194</a:t>
              </a:r>
              <a:endParaRPr lang="es-ES" sz="1400" dirty="0">
                <a:latin typeface="Times New Roman"/>
                <a:cs typeface="Times New Roman"/>
              </a:endParaRPr>
            </a:p>
          </p:txBody>
        </p:sp>
        <p:sp>
          <p:nvSpPr>
            <p:cNvPr id="23" name="Cerrar llave 22"/>
            <p:cNvSpPr/>
            <p:nvPr/>
          </p:nvSpPr>
          <p:spPr>
            <a:xfrm>
              <a:off x="6576128" y="267357"/>
              <a:ext cx="139655" cy="2455637"/>
            </a:xfrm>
            <a:prstGeom prst="rightBrac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27" name="Imagen 26" descr="Chelyconus ermineus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ackgroundRemoval t="2187" b="95626" l="7020" r="44556">
                          <a14:foregroundMark x1="41691" y1="23260" x2="41691" y2="23260"/>
                          <a14:foregroundMark x1="42407" y1="20676" x2="42407" y2="20676"/>
                          <a14:foregroundMark x1="41977" y1="26640" x2="41977" y2="26640"/>
                          <a14:foregroundMark x1="41834" y1="34195" x2="41834" y2="34195"/>
                          <a14:foregroundMark x1="42837" y1="29423" x2="42837" y2="29423"/>
                          <a14:foregroundMark x1="42693" y1="23260" x2="42693" y2="23260"/>
                          <a14:foregroundMark x1="41977" y1="31412" x2="41977" y2="31412"/>
                          <a14:foregroundMark x1="42837" y1="31014" x2="42837" y2="31014"/>
                          <a14:foregroundMark x1="43266" y1="27634" x2="43266" y2="27634"/>
                          <a14:foregroundMark x1="43266" y1="21869" x2="43266" y2="21869"/>
                          <a14:foregroundMark x1="32378" y1="81312" x2="32378" y2="81312"/>
                          <a14:foregroundMark x1="36103" y1="61829" x2="36103" y2="61829"/>
                          <a14:foregroundMark x1="37393" y1="58847" x2="37393" y2="58847"/>
                          <a14:foregroundMark x1="37966" y1="56262" x2="37966" y2="56262"/>
                          <a14:foregroundMark x1="38539" y1="54274" x2="38539" y2="54274"/>
                          <a14:foregroundMark x1="39971" y1="46123" x2="39971" y2="46123"/>
                          <a14:foregroundMark x1="40831" y1="41153" x2="40831" y2="41153"/>
                          <a14:foregroundMark x1="41261" y1="38966" x2="41261" y2="38966"/>
                          <a14:foregroundMark x1="42120" y1="37575" x2="42120" y2="37575"/>
                          <a14:foregroundMark x1="40258" y1="44334" x2="40258" y2="44334"/>
                          <a14:foregroundMark x1="10888" y1="48907" x2="10888" y2="48907"/>
                          <a14:foregroundMark x1="9885" y1="46720" x2="9885" y2="46720"/>
                          <a14:foregroundMark x1="9885" y1="44930" x2="9885" y2="44930"/>
                          <a14:foregroundMark x1="9742" y1="42346" x2="9742" y2="42346"/>
                          <a14:foregroundMark x1="8739" y1="26640" x2="8739" y2="26640"/>
                          <a14:foregroundMark x1="8739" y1="24254" x2="8739" y2="24254"/>
                          <a14:foregroundMark x1="12607" y1="17893" x2="12607" y2="17893"/>
                          <a14:foregroundMark x1="15473" y1="15308" x2="15473" y2="15308"/>
                          <a14:foregroundMark x1="39398" y1="15109" x2="39398" y2="15109"/>
                          <a14:foregroundMark x1="40688" y1="17097" x2="40688" y2="17097"/>
                          <a14:backgroundMark x1="16332" y1="14314" x2="16332" y2="1431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2" r="53108"/>
            <a:stretch/>
          </p:blipFill>
          <p:spPr>
            <a:xfrm rot="16200000">
              <a:off x="5710441" y="5930660"/>
              <a:ext cx="434675" cy="744764"/>
            </a:xfrm>
            <a:prstGeom prst="rect">
              <a:avLst/>
            </a:prstGeom>
          </p:spPr>
        </p:pic>
        <p:pic>
          <p:nvPicPr>
            <p:cNvPr id="29" name="Imagen 28" descr="Pionoconus consors IUCN.jpg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2667" b="96667" l="28000" r="73556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45" r="24222" b="4191"/>
            <a:stretch/>
          </p:blipFill>
          <p:spPr>
            <a:xfrm rot="16200000">
              <a:off x="7174959" y="2688804"/>
              <a:ext cx="390611" cy="681870"/>
            </a:xfrm>
            <a:prstGeom prst="rect">
              <a:avLst/>
            </a:prstGeom>
          </p:spPr>
        </p:pic>
        <p:pic>
          <p:nvPicPr>
            <p:cNvPr id="31" name="Imagen 30" descr="Fulgiconus goudeyi MNHN.jpeg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3247" b="94156" l="6250" r="4475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9" r="53392" b="3652"/>
            <a:stretch/>
          </p:blipFill>
          <p:spPr>
            <a:xfrm rot="16200000">
              <a:off x="5722086" y="3523156"/>
              <a:ext cx="441887" cy="775266"/>
            </a:xfrm>
            <a:prstGeom prst="rect">
              <a:avLst/>
            </a:prstGeom>
          </p:spPr>
        </p:pic>
        <p:pic>
          <p:nvPicPr>
            <p:cNvPr id="44" name="Imagen 4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16200000">
              <a:off x="7153035" y="1490177"/>
              <a:ext cx="478405" cy="746523"/>
            </a:xfrm>
            <a:prstGeom prst="rect">
              <a:avLst/>
            </a:prstGeom>
          </p:spPr>
        </p:pic>
        <p:sp>
          <p:nvSpPr>
            <p:cNvPr id="45" name="CuadroTexto 44"/>
            <p:cNvSpPr txBox="1"/>
            <p:nvPr/>
          </p:nvSpPr>
          <p:spPr>
            <a:xfrm>
              <a:off x="4487287" y="2424590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4840209" y="197503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3364789" y="4195052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48" name="CuadroTexto 47"/>
            <p:cNvSpPr txBox="1"/>
            <p:nvPr/>
          </p:nvSpPr>
          <p:spPr>
            <a:xfrm>
              <a:off x="3364789" y="498517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1388487" y="5300001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50" name="CuadroTexto 49"/>
            <p:cNvSpPr txBox="1"/>
            <p:nvPr/>
          </p:nvSpPr>
          <p:spPr>
            <a:xfrm>
              <a:off x="2544187" y="2773161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100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>
              <a:off x="347087" y="3182823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87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177438" y="5631470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94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sp>
          <p:nvSpPr>
            <p:cNvPr id="55" name="CuadroTexto 54"/>
            <p:cNvSpPr txBox="1"/>
            <p:nvPr/>
          </p:nvSpPr>
          <p:spPr>
            <a:xfrm>
              <a:off x="960604" y="6316544"/>
              <a:ext cx="453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>
                  <a:latin typeface="Times New Roman"/>
                  <a:cs typeface="Times New Roman"/>
                </a:rPr>
                <a:t>0.08</a:t>
              </a:r>
              <a:endParaRPr lang="es-ES" sz="1200" dirty="0">
                <a:latin typeface="Times New Roman"/>
                <a:cs typeface="Times New Roman"/>
              </a:endParaRPr>
            </a:p>
          </p:txBody>
        </p:sp>
        <p:pic>
          <p:nvPicPr>
            <p:cNvPr id="2" name="Imagen 1" descr="s-l1600.jpg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29487" b="77244" l="13375" r="86875">
                          <a14:backgroundMark x1="67375" y1="75641" x2="67375" y2="75641"/>
                          <a14:backgroundMark x1="78000" y1="75000" x2="78000" y2="75000"/>
                          <a14:backgroundMark x1="19125" y1="57853" x2="19125" y2="57853"/>
                          <a14:backgroundMark x1="83250" y1="62500" x2="83250" y2="62500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89" t="28799" r="11122" b="22372"/>
            <a:stretch/>
          </p:blipFill>
          <p:spPr>
            <a:xfrm flipH="1">
              <a:off x="7643996" y="5653585"/>
              <a:ext cx="723701" cy="358945"/>
            </a:xfrm>
            <a:prstGeom prst="rect">
              <a:avLst/>
            </a:prstGeom>
          </p:spPr>
        </p:pic>
        <p:pic>
          <p:nvPicPr>
            <p:cNvPr id="3" name="Imagen 2" descr="s-l1600.jpg"/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4583" b="88646" l="35438" r="85563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416" t="4873" r="14029" b="11253"/>
            <a:stretch/>
          </p:blipFill>
          <p:spPr>
            <a:xfrm rot="18857117">
              <a:off x="7056720" y="4696944"/>
              <a:ext cx="630138" cy="627256"/>
            </a:xfrm>
            <a:prstGeom prst="rect">
              <a:avLst/>
            </a:prstGeom>
          </p:spPr>
        </p:pic>
        <p:pic>
          <p:nvPicPr>
            <p:cNvPr id="25" name="Imagen 24" descr="s-l1600.jpg"/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27667" b="78500" l="11125" r="86750">
                          <a14:backgroundMark x1="18375" y1="60000" x2="18375" y2="60000"/>
                          <a14:backgroundMark x1="26125" y1="68500" x2="26125" y2="68500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05" t="27222" r="12596" b="22372"/>
            <a:stretch/>
          </p:blipFill>
          <p:spPr>
            <a:xfrm>
              <a:off x="6985060" y="5262172"/>
              <a:ext cx="780439" cy="383670"/>
            </a:xfrm>
            <a:prstGeom prst="rect">
              <a:avLst/>
            </a:prstGeom>
          </p:spPr>
        </p:pic>
        <p:pic>
          <p:nvPicPr>
            <p:cNvPr id="28" name="Imagen 27" descr="s-l1600-1.jpg"/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4195" b="90528" l="3542" r="95717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187447">
              <a:off x="8034955" y="3970827"/>
              <a:ext cx="829159" cy="504735"/>
            </a:xfrm>
            <a:prstGeom prst="rect">
              <a:avLst/>
            </a:prstGeom>
          </p:spPr>
        </p:pic>
        <p:pic>
          <p:nvPicPr>
            <p:cNvPr id="30" name="Imagen 29" descr="s-l1600.jpg"/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5200" b="99400" l="5838" r="59645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98" r="40073"/>
            <a:stretch/>
          </p:blipFill>
          <p:spPr>
            <a:xfrm rot="16200000">
              <a:off x="7859017" y="4325958"/>
              <a:ext cx="381457" cy="776301"/>
            </a:xfrm>
            <a:prstGeom prst="rect">
              <a:avLst/>
            </a:prstGeom>
          </p:spPr>
        </p:pic>
        <p:pic>
          <p:nvPicPr>
            <p:cNvPr id="32" name="Imagen 31" descr="s-l1600.jpg"/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ackgroundRemoval t="10000" b="72750" l="10000" r="90000">
                          <a14:foregroundMark x1="33313" y1="66667" x2="33313" y2="66667"/>
                          <a14:foregroundMark x1="46125" y1="67083" x2="46125" y2="67083"/>
                          <a14:foregroundMark x1="49563" y1="67917" x2="49563" y2="67917"/>
                          <a14:foregroundMark x1="49563" y1="67917" x2="49563" y2="67917"/>
                          <a14:foregroundMark x1="73938" y1="63167" x2="73938" y2="63167"/>
                          <a14:foregroundMark x1="70188" y1="63917" x2="70188" y2="63917"/>
                          <a14:foregroundMark x1="72063" y1="64417" x2="72063" y2="64417"/>
                          <a14:foregroundMark x1="68000" y1="66083" x2="68000" y2="66083"/>
                          <a14:foregroundMark x1="66250" y1="66250" x2="66250" y2="66250"/>
                          <a14:foregroundMark x1="70625" y1="65833" x2="70625" y2="65833"/>
                          <a14:foregroundMark x1="46500" y1="68500" x2="46500" y2="68500"/>
                          <a14:foregroundMark x1="43250" y1="68583" x2="43250" y2="68583"/>
                          <a14:foregroundMark x1="64875" y1="67000" x2="64875" y2="67000"/>
                          <a14:foregroundMark x1="68313" y1="69417" x2="68313" y2="69417"/>
                          <a14:foregroundMark x1="65938" y1="66833" x2="65938" y2="66833"/>
                          <a14:foregroundMark x1="28313" y1="64750" x2="28313" y2="64750"/>
                          <a14:foregroundMark x1="29688" y1="65667" x2="29688" y2="65667"/>
                          <a14:foregroundMark x1="44313" y1="70000" x2="44313" y2="70000"/>
                          <a14:foregroundMark x1="42688" y1="69417" x2="42688" y2="69417"/>
                          <a14:foregroundMark x1="39625" y1="69083" x2="39625" y2="69083"/>
                          <a14:foregroundMark x1="38500" y1="69583" x2="38500" y2="69583"/>
                          <a14:foregroundMark x1="38500" y1="69583" x2="38500" y2="69583"/>
                          <a14:foregroundMark x1="50688" y1="69083" x2="50688" y2="69083"/>
                          <a14:foregroundMark x1="50688" y1="69083" x2="50688" y2="69083"/>
                          <a14:foregroundMark x1="48188" y1="69833" x2="48188" y2="69833"/>
                          <a14:foregroundMark x1="48188" y1="69833" x2="48188" y2="69833"/>
                          <a14:foregroundMark x1="49250" y1="69667" x2="49250" y2="69667"/>
                          <a14:foregroundMark x1="49250" y1="69667" x2="49250" y2="69667"/>
                          <a14:foregroundMark x1="55813" y1="69083" x2="55813" y2="69083"/>
                          <a14:foregroundMark x1="31500" y1="66833" x2="31500" y2="66833"/>
                          <a14:foregroundMark x1="31500" y1="66833" x2="31500" y2="66833"/>
                          <a14:foregroundMark x1="41188" y1="69500" x2="41188" y2="69500"/>
                          <a14:foregroundMark x1="41188" y1="69500" x2="41188" y2="69500"/>
                          <a14:foregroundMark x1="40188" y1="69750" x2="40188" y2="69750"/>
                          <a14:foregroundMark x1="40188" y1="69750" x2="40188" y2="69750"/>
                          <a14:foregroundMark x1="41938" y1="69833" x2="41938" y2="69833"/>
                          <a14:foregroundMark x1="41938" y1="69833" x2="41938" y2="69833"/>
                          <a14:foregroundMark x1="43313" y1="70083" x2="43313" y2="70083"/>
                          <a14:foregroundMark x1="43313" y1="70083" x2="43313" y2="70083"/>
                          <a14:foregroundMark x1="37438" y1="69583" x2="37438" y2="69583"/>
                          <a14:foregroundMark x1="37438" y1="69583" x2="37438" y2="69583"/>
                          <a14:foregroundMark x1="36313" y1="69583" x2="36313" y2="69583"/>
                          <a14:foregroundMark x1="36313" y1="69583" x2="36313" y2="69583"/>
                          <a14:foregroundMark x1="56875" y1="68750" x2="56875" y2="68750"/>
                          <a14:foregroundMark x1="56875" y1="68750" x2="56875" y2="68750"/>
                          <a14:foregroundMark x1="55000" y1="69333" x2="55000" y2="69333"/>
                          <a14:foregroundMark x1="55000" y1="69333" x2="55000" y2="69333"/>
                          <a14:foregroundMark x1="74000" y1="63833" x2="74000" y2="63833"/>
                          <a14:foregroundMark x1="74000" y1="63833" x2="74000" y2="63833"/>
                          <a14:foregroundMark x1="73500" y1="64333" x2="73500" y2="64333"/>
                          <a14:foregroundMark x1="73500" y1="64333" x2="73500" y2="64333"/>
                          <a14:foregroundMark x1="75063" y1="64250" x2="75063" y2="64250"/>
                          <a14:foregroundMark x1="75063" y1="64250" x2="75063" y2="64250"/>
                          <a14:foregroundMark x1="23125" y1="58750" x2="23125" y2="58750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49956" y="3182823"/>
              <a:ext cx="960604" cy="720453"/>
            </a:xfrm>
            <a:prstGeom prst="rect">
              <a:avLst/>
            </a:prstGeom>
          </p:spPr>
        </p:pic>
      </p:grpSp>
      <p:sp>
        <p:nvSpPr>
          <p:cNvPr id="24" name="CuadroTexto 23"/>
          <p:cNvSpPr txBox="1"/>
          <p:nvPr/>
        </p:nvSpPr>
        <p:spPr>
          <a:xfrm>
            <a:off x="391429" y="6054965"/>
            <a:ext cx="84983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. S1</a:t>
            </a:r>
            <a:r>
              <a:rPr lang="en-US" sz="1200" dirty="0" smtClean="0"/>
              <a:t>. ML phylogeny of cone species based on </a:t>
            </a:r>
            <a:r>
              <a:rPr lang="en-US" sz="1200" dirty="0" err="1" smtClean="0"/>
              <a:t>mitogenomes</a:t>
            </a:r>
            <a:r>
              <a:rPr lang="en-US" sz="1200" dirty="0" smtClean="0"/>
              <a:t>. Best-fit model were estimated for the 13 protein-coding genes (</a:t>
            </a:r>
            <a:r>
              <a:rPr lang="en-US" sz="1200" dirty="0" err="1" smtClean="0"/>
              <a:t>aa</a:t>
            </a:r>
            <a:r>
              <a:rPr lang="en-US" sz="1200" dirty="0" smtClean="0"/>
              <a:t> level)  and the two </a:t>
            </a:r>
            <a:r>
              <a:rPr lang="en-US" sz="1200" dirty="0" err="1" smtClean="0"/>
              <a:t>rRNA</a:t>
            </a:r>
            <a:r>
              <a:rPr lang="en-US" sz="1200" dirty="0" smtClean="0"/>
              <a:t> genes (nucleotide level).  ML trees were reconstructed using </a:t>
            </a:r>
            <a:r>
              <a:rPr lang="en-US" sz="1200" dirty="0" err="1" smtClean="0"/>
              <a:t>PhyML</a:t>
            </a:r>
            <a:r>
              <a:rPr lang="en-US" sz="1200" dirty="0"/>
              <a:t> </a:t>
            </a:r>
            <a:r>
              <a:rPr lang="en-US" sz="1200" dirty="0" smtClean="0"/>
              <a:t>and 1000 bootstraps. The bootstraps support is shown in the nodes</a:t>
            </a:r>
            <a:r>
              <a:rPr lang="en-US" sz="1200" dirty="0"/>
              <a:t>. Scale bar indicates expected substitutions/site. </a:t>
            </a:r>
            <a:r>
              <a:rPr lang="en-US" sz="1200" dirty="0" err="1" smtClean="0"/>
              <a:t>GenBank</a:t>
            </a:r>
            <a:r>
              <a:rPr lang="en-US" sz="1200" dirty="0" smtClean="0"/>
              <a:t> accession numbers are indicated for </a:t>
            </a:r>
            <a:r>
              <a:rPr lang="en-US" sz="1200" i="1" dirty="0" smtClean="0"/>
              <a:t>P. magus</a:t>
            </a:r>
            <a:r>
              <a:rPr lang="en-US" sz="1200" dirty="0" smtClean="0"/>
              <a:t>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512289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114</Words>
  <Application>Microsoft Macintosh PowerPoint</Application>
  <PresentationFormat>Presentación en pantalla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cmini</dc:creator>
  <cp:lastModifiedBy>Rafael Zardoya </cp:lastModifiedBy>
  <cp:revision>15</cp:revision>
  <dcterms:created xsi:type="dcterms:W3CDTF">2019-07-20T09:42:37Z</dcterms:created>
  <dcterms:modified xsi:type="dcterms:W3CDTF">2019-07-29T07:11:39Z</dcterms:modified>
</cp:coreProperties>
</file>